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610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6464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084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968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3078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1478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626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872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685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6111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9791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5373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393EF-4BB3-4D8D-AEFD-4C49714D0C03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9E3F8-ED98-4EB1-8DF1-7A68204A2A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0108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8545" y="-1564224"/>
            <a:ext cx="5194473" cy="7142400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359F23BD-B70D-4745-B218-27E14D081844}"/>
              </a:ext>
            </a:extLst>
          </p:cNvPr>
          <p:cNvSpPr/>
          <p:nvPr/>
        </p:nvSpPr>
        <p:spPr>
          <a:xfrm>
            <a:off x="1860649" y="817195"/>
            <a:ext cx="83227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D837BC0-B7FD-4D49-B651-44C02B4F7C11}"/>
              </a:ext>
            </a:extLst>
          </p:cNvPr>
          <p:cNvSpPr/>
          <p:nvPr/>
        </p:nvSpPr>
        <p:spPr>
          <a:xfrm rot="17400000">
            <a:off x="4011846" y="2066385"/>
            <a:ext cx="152442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1CF8E65-760C-43CA-AF59-51AA17CF4C84}"/>
              </a:ext>
            </a:extLst>
          </p:cNvPr>
          <p:cNvSpPr/>
          <p:nvPr/>
        </p:nvSpPr>
        <p:spPr>
          <a:xfrm rot="17400000">
            <a:off x="3850906" y="2364582"/>
            <a:ext cx="88975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093911" y="2081464"/>
            <a:ext cx="7200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矩形 25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3778839" y="1746259"/>
            <a:ext cx="13840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3D837BC0-B7FD-4D49-B651-44C02B4F7C11}"/>
              </a:ext>
            </a:extLst>
          </p:cNvPr>
          <p:cNvSpPr/>
          <p:nvPr/>
        </p:nvSpPr>
        <p:spPr>
          <a:xfrm rot="17400000">
            <a:off x="5079932" y="2066385"/>
            <a:ext cx="152442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51CF8E65-760C-43CA-AF59-51AA17CF4C84}"/>
              </a:ext>
            </a:extLst>
          </p:cNvPr>
          <p:cNvSpPr/>
          <p:nvPr/>
        </p:nvSpPr>
        <p:spPr>
          <a:xfrm rot="17400000">
            <a:off x="4905989" y="2364582"/>
            <a:ext cx="88975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5253157" y="2079265"/>
            <a:ext cx="7200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" name="矩形 29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5255838" y="1747921"/>
            <a:ext cx="73327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 flipH="1">
            <a:off x="6307601" y="2590089"/>
            <a:ext cx="585417" cy="276999"/>
            <a:chOff x="-4002962" y="10215563"/>
            <a:chExt cx="585417" cy="276999"/>
          </a:xfrm>
        </p:grpSpPr>
        <p:sp>
          <p:nvSpPr>
            <p:cNvPr id="32" name="矩形 31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" name="组合 33"/>
          <p:cNvGrpSpPr/>
          <p:nvPr/>
        </p:nvGrpSpPr>
        <p:grpSpPr>
          <a:xfrm flipH="1">
            <a:off x="6307601" y="3101243"/>
            <a:ext cx="585417" cy="276999"/>
            <a:chOff x="-4002962" y="10215563"/>
            <a:chExt cx="585417" cy="276999"/>
          </a:xfrm>
        </p:grpSpPr>
        <p:sp>
          <p:nvSpPr>
            <p:cNvPr id="35" name="矩形 34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接连接符 35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矩形 17"/>
          <p:cNvSpPr/>
          <p:nvPr/>
        </p:nvSpPr>
        <p:spPr>
          <a:xfrm>
            <a:off x="3959658" y="2926080"/>
            <a:ext cx="851417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5053898" y="2946401"/>
            <a:ext cx="851417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1994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6661" y="-2371338"/>
            <a:ext cx="5195009" cy="7143137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3D837BC0-B7FD-4D49-B651-44C02B4F7C11}"/>
              </a:ext>
            </a:extLst>
          </p:cNvPr>
          <p:cNvSpPr/>
          <p:nvPr/>
        </p:nvSpPr>
        <p:spPr>
          <a:xfrm rot="17400000">
            <a:off x="4011846" y="2157825"/>
            <a:ext cx="152442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51CF8E65-760C-43CA-AF59-51AA17CF4C84}"/>
              </a:ext>
            </a:extLst>
          </p:cNvPr>
          <p:cNvSpPr/>
          <p:nvPr/>
        </p:nvSpPr>
        <p:spPr>
          <a:xfrm rot="17400000">
            <a:off x="3850906" y="2456022"/>
            <a:ext cx="88975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093911" y="2172904"/>
            <a:ext cx="7200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矩形 7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3778839" y="1837699"/>
            <a:ext cx="13840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327145F1-DEF5-43BB-BF9A-9191F1AFAE2D}"/>
              </a:ext>
            </a:extLst>
          </p:cNvPr>
          <p:cNvSpPr/>
          <p:nvPr/>
        </p:nvSpPr>
        <p:spPr>
          <a:xfrm>
            <a:off x="1555495" y="750075"/>
            <a:ext cx="62388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D837BC0-B7FD-4D49-B651-44C02B4F7C11}"/>
              </a:ext>
            </a:extLst>
          </p:cNvPr>
          <p:cNvSpPr/>
          <p:nvPr/>
        </p:nvSpPr>
        <p:spPr>
          <a:xfrm rot="17400000">
            <a:off x="5079932" y="2157825"/>
            <a:ext cx="152442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51CF8E65-760C-43CA-AF59-51AA17CF4C84}"/>
              </a:ext>
            </a:extLst>
          </p:cNvPr>
          <p:cNvSpPr/>
          <p:nvPr/>
        </p:nvSpPr>
        <p:spPr>
          <a:xfrm rot="17400000">
            <a:off x="4905989" y="2456022"/>
            <a:ext cx="88975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5253157" y="2170705"/>
            <a:ext cx="7200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矩形 20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5255838" y="1839361"/>
            <a:ext cx="73327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3111411" y="2885029"/>
            <a:ext cx="585417" cy="276999"/>
            <a:chOff x="-4002962" y="10215563"/>
            <a:chExt cx="585417" cy="276999"/>
          </a:xfrm>
        </p:grpSpPr>
        <p:sp>
          <p:nvSpPr>
            <p:cNvPr id="24" name="矩形 23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2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" name="组合 25"/>
          <p:cNvGrpSpPr/>
          <p:nvPr/>
        </p:nvGrpSpPr>
        <p:grpSpPr>
          <a:xfrm>
            <a:off x="3111411" y="3396183"/>
            <a:ext cx="585417" cy="276999"/>
            <a:chOff x="-4002962" y="10215563"/>
            <a:chExt cx="585417" cy="276999"/>
          </a:xfrm>
        </p:grpSpPr>
        <p:sp>
          <p:nvSpPr>
            <p:cNvPr id="27" name="矩形 26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接连接符 27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矩形 21"/>
          <p:cNvSpPr/>
          <p:nvPr/>
        </p:nvSpPr>
        <p:spPr>
          <a:xfrm>
            <a:off x="3959658" y="2926080"/>
            <a:ext cx="851417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5016793" y="2935589"/>
            <a:ext cx="851417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8589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Office PowerPoint</Application>
  <PresentationFormat>宽屏</PresentationFormat>
  <Paragraphs>1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3</cp:revision>
  <dcterms:created xsi:type="dcterms:W3CDTF">2024-02-08T05:28:55Z</dcterms:created>
  <dcterms:modified xsi:type="dcterms:W3CDTF">2024-02-12T00:29:53Z</dcterms:modified>
</cp:coreProperties>
</file>